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60059"/>
    <a:srgbClr val="AA0065"/>
    <a:srgbClr val="003969"/>
    <a:srgbClr val="65AA00"/>
    <a:srgbClr val="0092F7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7" d="100"/>
          <a:sy n="77" d="100"/>
        </p:scale>
        <p:origin x="6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931815944881889"/>
          <c:y val="0.12936078190447944"/>
          <c:w val="0.54136368110236222"/>
          <c:h val="0.81204547169995867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explosion val="15"/>
          <c:dPt>
            <c:idx val="0"/>
            <c:bubble3D val="0"/>
            <c:explosion val="0"/>
            <c:spPr>
              <a:solidFill>
                <a:schemeClr val="accent6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EE58-43F2-A869-78EF2BCE9798}"/>
              </c:ext>
            </c:extLst>
          </c:dPt>
          <c:dPt>
            <c:idx val="1"/>
            <c:bubble3D val="0"/>
            <c:explosion val="0"/>
            <c:spPr>
              <a:solidFill>
                <a:schemeClr val="accent5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EE58-43F2-A869-78EF2BCE9798}"/>
              </c:ext>
            </c:extLst>
          </c:dPt>
          <c:dPt>
            <c:idx val="2"/>
            <c:bubble3D val="0"/>
            <c:explosion val="8"/>
            <c:spPr>
              <a:solidFill>
                <a:schemeClr val="accent4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EE58-43F2-A869-78EF2BCE9798}"/>
              </c:ext>
            </c:extLst>
          </c:dPt>
          <c:dLbls>
            <c:dLbl>
              <c:idx val="0"/>
              <c:layout>
                <c:manualLayout>
                  <c:x val="-1.7264969341548097E-2"/>
                  <c:y val="0.11300017577976113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E58-43F2-A869-78EF2BCE9798}"/>
                </c:ext>
              </c:extLst>
            </c:dLbl>
            <c:dLbl>
              <c:idx val="1"/>
              <c:layout>
                <c:manualLayout>
                  <c:x val="-5.0362047917545165E-2"/>
                  <c:y val="5.9761752295777432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EE58-43F2-A869-78EF2BCE9798}"/>
                </c:ext>
              </c:extLst>
            </c:dLbl>
            <c:dLbl>
              <c:idx val="2"/>
              <c:layout>
                <c:manualLayout>
                  <c:x val="0.14048423738014904"/>
                  <c:y val="-0.28654772015321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197" b="1" i="0" u="none" strike="noStrike" kern="1200" baseline="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6.8853809405967373E-2"/>
                      <c:h val="4.8656366918489409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5-EE58-43F2-A869-78EF2BCE979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early AKI</c:v>
                </c:pt>
                <c:pt idx="1">
                  <c:v>non-early aki</c:v>
                </c:pt>
                <c:pt idx="2">
                  <c:v>no AKI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0.04</c:v>
                </c:pt>
                <c:pt idx="1">
                  <c:v>0.1</c:v>
                </c:pt>
                <c:pt idx="2">
                  <c:v>0.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E58-43F2-A869-78EF2BCE9798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8873968808816344"/>
          <c:y val="0.68644473529996664"/>
          <c:w val="0.14983464481856604"/>
          <c:h val="0.2426751419283304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lt1"/>
    </cs:fontRef>
    <cs:defRPr sz="1197" b="1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scene3d>
        <a:camera prst="orthographicFront"/>
        <a:lightRig rig="brightRoom" dir="t"/>
      </a:scene3d>
      <a:sp3d prstMaterial="flat">
        <a:bevelT w="50800" h="101600" prst="angle"/>
        <a:contourClr>
          <a:srgbClr val="000000"/>
        </a:contourClr>
      </a:sp3d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1" i="0" kern="1200" cap="all" spc="5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1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3EEA44-F0DB-C072-43B5-A6A72097B7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DCF2DC8B-6072-CEFF-90DF-C88D991EF945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00000"/>
              </a:lnSpc>
            </a:pPr>
            <a:r>
              <a:rPr lang="en-US" sz="24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incidence of acute kidney injury in very low birth weight  infants </a:t>
            </a:r>
            <a:r>
              <a:rPr lang="en-US" sz="2400" b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n-US" sz="24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arly Caffeine treatment</a:t>
            </a:r>
            <a:endParaRPr lang="en-US" sz="24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F3BFD4C-BDA4-5E83-802F-ADCFEE07D1F9}"/>
              </a:ext>
            </a:extLst>
          </p:cNvPr>
          <p:cNvSpPr txBox="1"/>
          <p:nvPr/>
        </p:nvSpPr>
        <p:spPr>
          <a:xfrm>
            <a:off x="180182" y="1189759"/>
            <a:ext cx="11921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6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sess the incidence of AKI in VLBW infants treated uniformly with early high dose caffeine.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E5D7956-CA6B-60AB-F6F7-2FE110C32255}"/>
              </a:ext>
            </a:extLst>
          </p:cNvPr>
          <p:cNvSpPr txBox="1"/>
          <p:nvPr/>
        </p:nvSpPr>
        <p:spPr>
          <a:xfrm>
            <a:off x="272881" y="1891693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37B7755-5B51-B331-31D4-A6137018EB6C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zvi-Behr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0CD5DA6-ADB4-945A-8267-8E4416CE65EF}"/>
              </a:ext>
            </a:extLst>
          </p:cNvPr>
          <p:cNvSpPr txBox="1"/>
          <p:nvPr/>
        </p:nvSpPr>
        <p:spPr>
          <a:xfrm>
            <a:off x="173448" y="5719172"/>
            <a:ext cx="7141846" cy="1985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incidence of AKI in a cohort of VLBW infants, uniformly early treated with Caffeine was significantly lower as compared to previous studies, especially in the first week of life.   </a:t>
            </a:r>
            <a:endParaRPr lang="en-US" sz="18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-----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B7795F5C-2376-C57A-F1F9-A107B9BB84EC}"/>
              </a:ext>
            </a:extLst>
          </p:cNvPr>
          <p:cNvSpPr/>
          <p:nvPr/>
        </p:nvSpPr>
        <p:spPr>
          <a:xfrm>
            <a:off x="508335" y="259493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1FF4B450-5D61-3CF4-FF5C-B686DEF66316}"/>
              </a:ext>
            </a:extLst>
          </p:cNvPr>
          <p:cNvSpPr/>
          <p:nvPr/>
        </p:nvSpPr>
        <p:spPr>
          <a:xfrm>
            <a:off x="799403" y="307921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5260568F-8DB4-2ED9-232F-259F466600CE}"/>
              </a:ext>
            </a:extLst>
          </p:cNvPr>
          <p:cNvSpPr/>
          <p:nvPr/>
        </p:nvSpPr>
        <p:spPr>
          <a:xfrm>
            <a:off x="1098340" y="253802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FF6F3700-345A-5C75-EEE2-3E10F4540DAA}"/>
              </a:ext>
            </a:extLst>
          </p:cNvPr>
          <p:cNvSpPr/>
          <p:nvPr/>
        </p:nvSpPr>
        <p:spPr>
          <a:xfrm>
            <a:off x="1405659" y="299970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7" name="Rectangle 48">
            <a:extLst>
              <a:ext uri="{FF2B5EF4-FFF2-40B4-BE49-F238E27FC236}">
                <a16:creationId xmlns:a16="http://schemas.microsoft.com/office/drawing/2014/main" id="{CD4619F4-BD3B-DD4E-6BDF-2676467EA7F6}"/>
              </a:ext>
            </a:extLst>
          </p:cNvPr>
          <p:cNvSpPr/>
          <p:nvPr/>
        </p:nvSpPr>
        <p:spPr>
          <a:xfrm>
            <a:off x="272593" y="4307834"/>
            <a:ext cx="1958357" cy="820756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301 VLBW infants treated uniformly with early high dose Caffeine</a:t>
            </a:r>
          </a:p>
        </p:txBody>
      </p:sp>
      <p:cxnSp>
        <p:nvCxnSpPr>
          <p:cNvPr id="8" name="Straight Arrow Connector 44">
            <a:extLst>
              <a:ext uri="{FF2B5EF4-FFF2-40B4-BE49-F238E27FC236}">
                <a16:creationId xmlns:a16="http://schemas.microsoft.com/office/drawing/2014/main" id="{3EE3AC8D-160C-9D2C-A81F-CD1DFF7D7C0B}"/>
              </a:ext>
            </a:extLst>
          </p:cNvPr>
          <p:cNvCxnSpPr>
            <a:cxnSpLocks/>
          </p:cNvCxnSpPr>
          <p:nvPr/>
        </p:nvCxnSpPr>
        <p:spPr>
          <a:xfrm>
            <a:off x="2448193" y="3399732"/>
            <a:ext cx="62837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9121807E-65AE-B95E-38F8-E915B296D75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085819652"/>
              </p:ext>
            </p:extLst>
          </p:nvPr>
        </p:nvGraphicFramePr>
        <p:xfrm>
          <a:off x="916558" y="1352814"/>
          <a:ext cx="7487821" cy="41586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טבלה 8">
            <a:extLst>
              <a:ext uri="{FF2B5EF4-FFF2-40B4-BE49-F238E27FC236}">
                <a16:creationId xmlns:a16="http://schemas.microsoft.com/office/drawing/2014/main" id="{F648B6A7-D1DD-BB7D-9602-4965868DE81F}"/>
              </a:ext>
            </a:extLst>
          </p:cNvPr>
          <p:cNvGraphicFramePr>
            <a:graphicFrameLocks noGrp="1"/>
          </p:cNvGraphicFramePr>
          <p:nvPr/>
        </p:nvGraphicFramePr>
        <p:xfrm>
          <a:off x="6695558" y="1658947"/>
          <a:ext cx="5491480" cy="396036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70100">
                  <a:extLst>
                    <a:ext uri="{9D8B030D-6E8A-4147-A177-3AD203B41FA5}">
                      <a16:colId xmlns:a16="http://schemas.microsoft.com/office/drawing/2014/main" val="2666193191"/>
                    </a:ext>
                  </a:extLst>
                </a:gridCol>
                <a:gridCol w="1170940">
                  <a:extLst>
                    <a:ext uri="{9D8B030D-6E8A-4147-A177-3AD203B41FA5}">
                      <a16:colId xmlns:a16="http://schemas.microsoft.com/office/drawing/2014/main" val="492205018"/>
                    </a:ext>
                  </a:extLst>
                </a:gridCol>
                <a:gridCol w="986790">
                  <a:extLst>
                    <a:ext uri="{9D8B030D-6E8A-4147-A177-3AD203B41FA5}">
                      <a16:colId xmlns:a16="http://schemas.microsoft.com/office/drawing/2014/main" val="548867989"/>
                    </a:ext>
                  </a:extLst>
                </a:gridCol>
                <a:gridCol w="1263650">
                  <a:extLst>
                    <a:ext uri="{9D8B030D-6E8A-4147-A177-3AD203B41FA5}">
                      <a16:colId xmlns:a16="http://schemas.microsoft.com/office/drawing/2014/main" val="1794287651"/>
                    </a:ext>
                  </a:extLst>
                </a:gridCol>
              </a:tblGrid>
              <a:tr h="3281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eonates with AKI 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(N=41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eonates without AKI 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(N=26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P-valu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21045992"/>
                  </a:ext>
                </a:extLst>
              </a:tr>
              <a:tr h="184150"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Risk factors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rgbClr val="960059"/>
                    </a:solidFill>
                  </a:tcPr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2734446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Sepsi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7 (17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14 (5.3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0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6116822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PDA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26 (63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51 (19.6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9163486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EC 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15 (36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6 (2.3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&lt;0.00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3679211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Nephrotoxic drugs exposur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32 (78 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197 (76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7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7742650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First-week Hemodynamic instability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13(31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13 (5%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&lt;0.0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53813901"/>
                  </a:ext>
                </a:extLst>
              </a:tr>
              <a:tr h="184150"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Outcomes and prognosis variabl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rgbClr val="960059"/>
                    </a:solidFill>
                  </a:tcPr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909822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BPD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17 (42%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47 (18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9218808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Length of hospitalization among survivors (days)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100 </a:t>
                      </a:r>
                      <a:r>
                        <a:rPr lang="en-US" sz="1100" dirty="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dirty="0">
                          <a:effectLst/>
                        </a:rPr>
                        <a:t> 111.2 </a:t>
                      </a:r>
                      <a:endParaRPr lang="en-US" sz="1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60.8 </a:t>
                      </a:r>
                      <a:r>
                        <a:rPr lang="en-US" sz="1100" dirty="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dirty="0">
                          <a:effectLst/>
                        </a:rPr>
                        <a:t> 29.6</a:t>
                      </a:r>
                      <a:endParaRPr lang="en-US" sz="1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7067584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Mortality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19 (46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6 (2.3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&lt;0.00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36260419"/>
                  </a:ext>
                </a:extLst>
              </a:tr>
              <a:tr h="22034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Weight at discharge (kg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2.44 </a:t>
                      </a:r>
                      <a:r>
                        <a:rPr lang="en-US" sz="110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>
                          <a:effectLst/>
                        </a:rPr>
                        <a:t> 1.7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2.64 </a:t>
                      </a:r>
                      <a:r>
                        <a:rPr lang="en-US" sz="110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>
                          <a:effectLst/>
                        </a:rPr>
                        <a:t> 0.8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0.484</a:t>
                      </a:r>
                      <a:r>
                        <a:rPr lang="he-IL" sz="800" dirty="0">
                          <a:effectLst/>
                        </a:rPr>
                        <a:t> 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933460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9932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50</TotalTime>
  <Words>229</Words>
  <Application>Microsoft Office PowerPoint</Application>
  <PresentationFormat>Widescreen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74</cp:revision>
  <dcterms:created xsi:type="dcterms:W3CDTF">2019-06-13T12:30:18Z</dcterms:created>
  <dcterms:modified xsi:type="dcterms:W3CDTF">2025-01-21T10:57:41Z</dcterms:modified>
</cp:coreProperties>
</file>